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AFAE5-E438-4F11-A962-33E0E566D4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08DC3-71A1-43C3-AB2F-6A4B8D808F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4FC05-A95F-4681-82A2-533F1CE73E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FF8D8-28F9-4D01-9D9E-978A6ED632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CE4C0-EF67-45AE-9482-0117D11CAA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FCEF5-130C-47BF-8EEC-CD3F02A4BD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6D09D-986C-44A9-A4FE-41DA31289B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8779A-C38E-4273-BA4D-BBBB8468AC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13684-F5FC-44AE-8ED2-BC003D90D2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5FFA8-D75D-48F1-A1E5-57F60CEE52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3176D-CE9F-4505-814C-7916349A55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1A18A-478B-485D-AB8E-E10311E175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ED2BD8-5A10-445E-A532-218891DE2BB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4680" y="4416480"/>
            <a:ext cx="1555920" cy="1029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1168560" y="4408560"/>
            <a:ext cx="1555560" cy="10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174680" y="3849840"/>
            <a:ext cx="192240" cy="1029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168560" y="3841920"/>
            <a:ext cx="191880" cy="102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174680" y="3284640"/>
            <a:ext cx="379440" cy="1047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1168560" y="3278160"/>
            <a:ext cx="37908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174680" y="2717640"/>
            <a:ext cx="849240" cy="1033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168560" y="2711520"/>
            <a:ext cx="849240" cy="102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174680" y="4313160"/>
            <a:ext cx="3008520" cy="1033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168560" y="4305240"/>
            <a:ext cx="300816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174680" y="3745080"/>
            <a:ext cx="1155600" cy="1047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168560" y="3738600"/>
            <a:ext cx="115560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174680" y="3181320"/>
            <a:ext cx="2790720" cy="1033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168560" y="3174840"/>
            <a:ext cx="279072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174680" y="2614680"/>
            <a:ext cx="2671920" cy="1029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168560" y="2606760"/>
            <a:ext cx="2671560" cy="10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1174680" y="4210200"/>
            <a:ext cx="2965680" cy="102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1168560" y="4202280"/>
            <a:ext cx="2965320" cy="102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1174680" y="3645000"/>
            <a:ext cx="731880" cy="10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168560" y="3638520"/>
            <a:ext cx="731520" cy="100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174680" y="3078000"/>
            <a:ext cx="1209600" cy="103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1168560" y="3071880"/>
            <a:ext cx="1209600" cy="102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174680" y="2514600"/>
            <a:ext cx="1525680" cy="10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168560" y="2508120"/>
            <a:ext cx="1525320" cy="98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1174680" y="4105440"/>
            <a:ext cx="2538360" cy="10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1168560" y="4098960"/>
            <a:ext cx="253836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1174680" y="3541680"/>
            <a:ext cx="2538360" cy="103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1168560" y="3535200"/>
            <a:ext cx="2538360" cy="103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1174680" y="2975040"/>
            <a:ext cx="2538360" cy="102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1168560" y="2967120"/>
            <a:ext cx="2538360" cy="10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1174680" y="2411280"/>
            <a:ext cx="2538360" cy="103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1168560" y="2403360"/>
            <a:ext cx="2538360" cy="104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2724120" y="4459320"/>
            <a:ext cx="281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3005280" y="441324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1360440" y="3890880"/>
            <a:ext cx="15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1376280" y="3844800"/>
            <a:ext cx="1800" cy="93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1547640" y="3327480"/>
            <a:ext cx="78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625760" y="3281400"/>
            <a:ext cx="144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2017800" y="2760840"/>
            <a:ext cx="156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174760" y="2714760"/>
            <a:ext cx="180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4176720" y="4356000"/>
            <a:ext cx="2649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441680" y="4308480"/>
            <a:ext cx="180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2324160" y="3787920"/>
            <a:ext cx="45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2774880" y="3741840"/>
            <a:ext cx="180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3959280" y="3224160"/>
            <a:ext cx="58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540320" y="317808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840120" y="2657520"/>
            <a:ext cx="558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398840" y="261144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133880" y="4251240"/>
            <a:ext cx="911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5045040" y="4205160"/>
            <a:ext cx="1800" cy="93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1900080" y="3684600"/>
            <a:ext cx="341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241720" y="363852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2378160" y="3121200"/>
            <a:ext cx="368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2746440" y="307512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2693880" y="2557440"/>
            <a:ext cx="441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135240" y="251136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706920" y="4148280"/>
            <a:ext cx="249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956040" y="4102200"/>
            <a:ext cx="144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3706920" y="3584520"/>
            <a:ext cx="8143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4521240" y="353844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3706920" y="3017880"/>
            <a:ext cx="328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035600" y="297180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706920" y="2454120"/>
            <a:ext cx="53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246560" y="240840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1168560" y="4587840"/>
            <a:ext cx="4568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116856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167652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218448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2690640" y="4587840"/>
            <a:ext cx="180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319896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370692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421488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472140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522936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5737320" y="4587840"/>
            <a:ext cx="1440" cy="31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1168560" y="2325600"/>
            <a:ext cx="1440" cy="2262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1139760" y="4587840"/>
            <a:ext cx="28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139760" y="4019400"/>
            <a:ext cx="28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1139760" y="3456000"/>
            <a:ext cx="28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1139760" y="2889360"/>
            <a:ext cx="28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1139760" y="2325600"/>
            <a:ext cx="28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2881080" y="1990800"/>
            <a:ext cx="159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e expression  in  Islet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1142640" y="46879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160416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211212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61720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312660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3682800" y="46879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414252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464760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515700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5664960" y="4687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849240" y="42418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RS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729720" y="3675240"/>
            <a:ext cx="41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LUT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739080" y="3111480"/>
            <a:ext cx="40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nsul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806400" y="2544840"/>
            <a:ext cx="32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DX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7" name=""/>
          <p:cNvGrpSpPr/>
          <p:nvPr/>
        </p:nvGrpSpPr>
        <p:grpSpPr>
          <a:xfrm>
            <a:off x="5450040" y="2743200"/>
            <a:ext cx="759600" cy="667080"/>
            <a:chOff x="5450040" y="2743200"/>
            <a:chExt cx="759600" cy="667080"/>
          </a:xfrm>
        </p:grpSpPr>
        <p:sp>
          <p:nvSpPr>
            <p:cNvPr id="138" name=""/>
            <p:cNvSpPr/>
            <p:nvPr/>
          </p:nvSpPr>
          <p:spPr>
            <a:xfrm>
              <a:off x="5452920" y="2772000"/>
              <a:ext cx="59760" cy="66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450040" y="2766960"/>
              <a:ext cx="66240" cy="74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535720" y="274320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452920" y="2941560"/>
              <a:ext cx="59760" cy="68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450040" y="2938680"/>
              <a:ext cx="66240" cy="74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526000" y="2914920"/>
              <a:ext cx="68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452920" y="3113280"/>
              <a:ext cx="59760" cy="680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450040" y="3110040"/>
              <a:ext cx="66240" cy="74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535000" y="3086280"/>
              <a:ext cx="34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452920" y="3284640"/>
              <a:ext cx="59760" cy="684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450040" y="3281400"/>
              <a:ext cx="66240" cy="74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534640" y="325764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50" name=""/>
          <p:cNvSpPr/>
          <p:nvPr/>
        </p:nvSpPr>
        <p:spPr>
          <a:xfrm>
            <a:off x="1050840" y="559764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730080" y="5597640"/>
            <a:ext cx="50230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e expression in islet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Islets mRNA levels from different genes from 16 wk-age male wild type, ob/ob, 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 KO and POKO mice fed chow (n=4-6). * P&lt;0.05, ** P&lt;0.01 POK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ob/ob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180160" y="2717640"/>
            <a:ext cx="31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1781640" y="3263760"/>
            <a:ext cx="26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3043800" y="4383000"/>
            <a:ext cx="31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2725200" y="4973760"/>
            <a:ext cx="136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5403240" y="838692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17:59Z</dcterms:modified>
  <cp:revision>67</cp:revision>
  <dc:subject/>
  <dc:title>PowerPoint Presentation</dc:title>
</cp:coreProperties>
</file>